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8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238128-16C5-C76B-5913-B803E75879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8149DE5-C422-A0BC-4141-CF40C970BB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C88191-048C-948E-340D-2011C0D4B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DD6BF0-F594-E9D3-B743-8683400A2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4054EC-B85A-6251-E902-3C90D6D00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013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9C68FA-BD84-8397-43DA-F663166B0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6B47106-07CA-8E39-63BA-92A27029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60330D-C138-0199-0E14-9C26A7B9C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1D5B53-8DBE-96E7-6B20-9731E2462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16E0EE-88FC-7E71-3673-E92C0AEDC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33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23A544C-1E68-9368-73F2-B6A797D09F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2F0EFDF-227C-A6F4-662B-DD797929A7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DDF673-FC13-E2C6-34A6-64E3133F0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784696-66CC-0AD4-6748-23E57717C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DB9F69-0020-7B04-0E14-F283FC10C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54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6B6BCC-C410-C9A7-1C5C-36589C79D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20415C4-5DAA-C88C-4C9F-8D3A26C5DE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53B827-8743-25E6-FF9E-2DE5C8412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5E62DB-F0CF-FFC4-3F6A-AC5BEC203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6DF0E4-A966-DCF0-9C1D-D72AF3EC9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1313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D3A475-6C96-188D-E1D4-0D656B4E3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FE4349-990E-40E5-C853-D9D9C8D746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D3C8E7-F01A-F427-AD14-AE8AAEF69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6ED414-0CF9-3A39-E231-27F6F1AE0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AEF03A-AE45-EF7D-D849-01C98E016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9935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FBD929-0C96-9DE8-EC97-C9C234E9F3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680CA25-0FD8-3ABE-FCD5-DDC050D258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FF50CA-B860-D345-0F81-ED08C2FC2A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EA3463C-FE14-FFC4-1C12-CE3821D7B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6E0C59-DD27-3C64-961F-678288209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CAAE92-A119-64BC-8E41-180725166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2302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35D42A-A33E-8E0B-FEAB-24ED680AB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205982-BE78-B344-BDA8-8A0671FF53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D5E4557-8298-A0BA-6399-32F56D1F46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D8DAC16-E7BB-7C96-50E5-9432BC30B8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4B1958D-CCC2-EFA9-CFE3-FF55CBE183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A434014-7C08-F45B-201C-170E49FDC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3E05C54-A4F8-4A58-FBAE-9278E4DEC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6B5CDBC-84DC-CB45-D913-D6F6591F3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7293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C55D36-F12E-BAE2-23DF-9E0EE7FCA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226F915-A096-8B3B-4523-F4AD8F9F1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3D95BF0-77FC-6B03-2750-537D5F472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8FB3D33-EB33-67D4-D470-8FC60DF50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381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5D0D96A-F583-4EFD-228B-147E47F77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35E1F54-3939-5FFE-80F0-95A1D18D3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EFDE062-8710-8578-A649-24C8F8E70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5376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0B83D2-AC56-AAF5-D3FC-1C7813631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95A6AEA-FC52-B336-D88F-EDE1EFFBE2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F79D96-9D4A-2E0F-DED0-CBF95D8E18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F464E1E-A5A8-94DE-FC4B-532762D09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38B746-A7F3-7369-180F-9741DF4F4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2399C34-39B3-2561-9656-B40369E90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2195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F71AF4-19B9-2DCE-11CF-AD9582BD07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75A8E2B-34DE-E5D8-F025-462EC84024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5A0152-8E06-8B02-B805-2F617BC410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5EA2C1C-C619-9F58-AE6C-89249F0C8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8A99AD-1D08-1D7F-49E8-C9BF56E85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8CF9BD-1157-C01D-35C9-17B376E58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387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7E19A7-8669-DFED-6025-CA4144F52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252A6DD-08E7-2335-992C-EADFB2D063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36694A-604A-D53A-BBEE-B0800621FA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EB859-61B3-4705-8B9D-D6F40F597665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CE239F-2283-8295-6CB6-BBECA050BB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0BFDEE-84A4-5712-18B4-10425220AC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AD7A5-E3FB-4781-AD64-D9EB12E4E3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479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jpg"/><Relationship Id="rId4" Type="http://schemas.openxmlformats.org/officeDocument/2006/relationships/image" Target="../media/image2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jpg"/><Relationship Id="rId4" Type="http://schemas.openxmlformats.org/officeDocument/2006/relationships/image" Target="../media/image31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jpg"/><Relationship Id="rId4" Type="http://schemas.openxmlformats.org/officeDocument/2006/relationships/image" Target="../media/image3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53D9CEE-807A-CEF4-4745-CC338775C49C}"/>
              </a:ext>
            </a:extLst>
          </p:cNvPr>
          <p:cNvSpPr txBox="1"/>
          <p:nvPr/>
        </p:nvSpPr>
        <p:spPr>
          <a:xfrm>
            <a:off x="0" y="0"/>
            <a:ext cx="1282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ISU1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C4F6C4E-D9DF-F9F7-BED5-7EEF828DD7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2073" y="1"/>
            <a:ext cx="3426692" cy="342669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0B7ED5E-4598-0E86-41E1-A38B800513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2073" y="3431308"/>
            <a:ext cx="3426692" cy="342669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5880240-0445-A94B-F074-ADFF0235434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5311" y="1"/>
            <a:ext cx="3426692" cy="342669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D236BAC-D359-4FCF-6D9C-D5395BFDCC3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5311" y="3431308"/>
            <a:ext cx="3426692" cy="3426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9453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91C3453-3C33-3C0A-9ABE-5CFFCA31128F}"/>
              </a:ext>
            </a:extLst>
          </p:cNvPr>
          <p:cNvSpPr txBox="1"/>
          <p:nvPr/>
        </p:nvSpPr>
        <p:spPr>
          <a:xfrm>
            <a:off x="0" y="0"/>
            <a:ext cx="1282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ISU1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D3B358A-120C-4677-4F76-E885899335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329" y="4619"/>
            <a:ext cx="3442856" cy="344285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B1ECEE4-A75E-544B-9EC6-8C87417743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329" y="3447475"/>
            <a:ext cx="3442856" cy="344285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4F68B32-AEB1-507C-14A7-5BDDF46BEA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346" y="4619"/>
            <a:ext cx="3442856" cy="344285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DD8BA028-32FA-9B0D-8088-D49B5E2A4B5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346" y="3447475"/>
            <a:ext cx="3442856" cy="3442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874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011A4D3-4B15-E76E-369E-708FF441D634}"/>
              </a:ext>
            </a:extLst>
          </p:cNvPr>
          <p:cNvSpPr txBox="1"/>
          <p:nvPr/>
        </p:nvSpPr>
        <p:spPr>
          <a:xfrm>
            <a:off x="0" y="0"/>
            <a:ext cx="1282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ISU1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243E198-0672-530D-34E3-90C3270261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854" y="0"/>
            <a:ext cx="3445164" cy="344516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EABB8D4-40CF-CBAD-D776-7779E803E9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854" y="3445164"/>
            <a:ext cx="3445164" cy="344516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6953114-67DA-0E7E-8337-D3BA1C8DB9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0"/>
            <a:ext cx="3445164" cy="344516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296A464-F76A-11F7-9D2B-329B334E91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445164"/>
            <a:ext cx="3445164" cy="3445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409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C498C98-7490-8E8C-02D4-20AC71C26CAE}"/>
              </a:ext>
            </a:extLst>
          </p:cNvPr>
          <p:cNvSpPr txBox="1"/>
          <p:nvPr/>
        </p:nvSpPr>
        <p:spPr>
          <a:xfrm>
            <a:off x="0" y="0"/>
            <a:ext cx="1521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HSCA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B8A2BBB-EBB3-E7EC-EEEE-56344A4BCE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764" y="0"/>
            <a:ext cx="3454400" cy="34544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E5AF8BD-67E3-27E5-8C5D-4255378764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764" y="3403600"/>
            <a:ext cx="3454400" cy="34544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DF5E6CB-D783-D405-ED32-8655C837F4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0"/>
            <a:ext cx="3454400" cy="34544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B39C8FB-A48C-A836-AF18-00CCB27E79A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403600"/>
            <a:ext cx="3454400" cy="345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29880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5112B3A-3692-1E82-C3A2-98A62E487767}"/>
              </a:ext>
            </a:extLst>
          </p:cNvPr>
          <p:cNvSpPr txBox="1"/>
          <p:nvPr/>
        </p:nvSpPr>
        <p:spPr>
          <a:xfrm>
            <a:off x="0" y="0"/>
            <a:ext cx="1521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HSCA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55D5BC1-A3EA-E37D-AAC6-FD6BE7F2C9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2983" y="0"/>
            <a:ext cx="3380509" cy="338050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01E4936-4B9D-B1CE-09E4-CCDC8FED0D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2983" y="3380509"/>
            <a:ext cx="3380509" cy="338050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8663A5D-4A3A-68E2-9DC7-DA5C416F40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345" y="-1"/>
            <a:ext cx="3380509" cy="338050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F298415-B30A-0E44-E534-CD59149EFAA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345" y="3380508"/>
            <a:ext cx="3380509" cy="33805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3878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C019662-80EF-7862-2B9B-F5D9B5DAC440}"/>
              </a:ext>
            </a:extLst>
          </p:cNvPr>
          <p:cNvSpPr txBox="1"/>
          <p:nvPr/>
        </p:nvSpPr>
        <p:spPr>
          <a:xfrm>
            <a:off x="0" y="0"/>
            <a:ext cx="1521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+HSCA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4AB0FAA-0182-AE47-41DC-6A46160696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382" y="0"/>
            <a:ext cx="3419763" cy="341976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6719BE0-682F-75B1-24F9-795079755C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382" y="3438238"/>
            <a:ext cx="3419763" cy="341976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4570F00-0E32-77A2-4BE0-60172CAE14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845" y="0"/>
            <a:ext cx="3419763" cy="341976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DC6910C-2413-0E31-6518-1DC0E825293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844" y="3438238"/>
            <a:ext cx="3419763" cy="34197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94943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7548D41-DE3F-31DF-9739-AEB88951949F}"/>
              </a:ext>
            </a:extLst>
          </p:cNvPr>
          <p:cNvSpPr txBox="1"/>
          <p:nvPr/>
        </p:nvSpPr>
        <p:spPr>
          <a:xfrm>
            <a:off x="0" y="0"/>
            <a:ext cx="1481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+HSCA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54B5810-7484-A341-601A-ADA694058E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9091" y="0"/>
            <a:ext cx="3435929" cy="343592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0647F80-FB3D-DD1A-A6E3-D79B99201B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9091" y="3435929"/>
            <a:ext cx="3435929" cy="343592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545982D-AD75-F0AB-8351-07F10F22E7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8363" y="3435929"/>
            <a:ext cx="3435929" cy="343592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48D4C88-3850-EAE7-E0B0-D396B7C179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8363" y="0"/>
            <a:ext cx="3435929" cy="34359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64960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4DC4E5A-2659-B859-27F0-212DB2099BBE}"/>
              </a:ext>
            </a:extLst>
          </p:cNvPr>
          <p:cNvSpPr txBox="1"/>
          <p:nvPr/>
        </p:nvSpPr>
        <p:spPr>
          <a:xfrm>
            <a:off x="0" y="0"/>
            <a:ext cx="1481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+HSCA2</a:t>
            </a:r>
            <a:endParaRPr lang="zh-CN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F83CDBB1-6275-862E-8FB0-C02039B486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0" y="0"/>
            <a:ext cx="3581400" cy="35814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68B48E0-3CAD-57B0-C1FC-60515A0693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0" y="3581400"/>
            <a:ext cx="3581400" cy="35814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5DE6D08-9B2B-0562-ECE6-4105084274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228" y="0"/>
            <a:ext cx="3581400" cy="35814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5465D87-71C7-192E-44CA-AD875BAE8E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228" y="3581400"/>
            <a:ext cx="3581400" cy="3581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0083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0C37F14-3958-E754-7A81-6E0A432476CA}"/>
              </a:ext>
            </a:extLst>
          </p:cNvPr>
          <p:cNvSpPr txBox="1"/>
          <p:nvPr/>
        </p:nvSpPr>
        <p:spPr>
          <a:xfrm>
            <a:off x="0" y="0"/>
            <a:ext cx="1481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+HSCA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FF68D60-4A77-D0E2-7F8A-85D9F6D723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0709" y="0"/>
            <a:ext cx="3655291" cy="365529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09F0DAC-E428-7201-A15F-8BD37C56D8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0709" y="3655290"/>
            <a:ext cx="3655291" cy="365529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8592D9F-9E56-F720-A873-E681D25F81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0354" y="-1"/>
            <a:ext cx="3655291" cy="365529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9D9808A-B1E7-E0CB-97CE-1E4A9A90083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0354" y="3655289"/>
            <a:ext cx="3655291" cy="36552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4053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27</Words>
  <Application>Microsoft Office PowerPoint</Application>
  <PresentationFormat>宽屏</PresentationFormat>
  <Paragraphs>9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ovo</dc:creator>
  <cp:lastModifiedBy>lenovo</cp:lastModifiedBy>
  <cp:revision>1</cp:revision>
  <dcterms:created xsi:type="dcterms:W3CDTF">2024-10-07T02:54:01Z</dcterms:created>
  <dcterms:modified xsi:type="dcterms:W3CDTF">2024-10-07T03:36:02Z</dcterms:modified>
</cp:coreProperties>
</file>